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8" autoAdjust="0"/>
    <p:restoredTop sz="94660"/>
  </p:normalViewPr>
  <p:slideViewPr>
    <p:cSldViewPr snapToGrid="0">
      <p:cViewPr>
        <p:scale>
          <a:sx n="66" d="100"/>
          <a:sy n="66" d="100"/>
        </p:scale>
        <p:origin x="1238" y="60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13BC14-F98A-4AA1-8680-040A356B79C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CBFAB03-5238-4928-98AC-109C29B23F9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B597BF6-11B5-4BDD-803D-BC2C3724BD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E3305C-62ED-462B-A6A7-46AC243B6703}" type="datetimeFigureOut">
              <a:rPr lang="en-GB" smtClean="0"/>
              <a:t>21/01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879FA7B-0DB0-45A8-A4DA-2F25FD1904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7FD8AF-694D-45D0-B3BA-50CB3DAAEE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9B8440-9585-4C94-ABBA-FBD027A79E6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296627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D17FF6-4988-45DC-91B2-99A34775AA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0A758E7-FB88-48C4-B2B8-2DB9BF13449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2163B6-0325-454D-B547-46E8B88492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E3305C-62ED-462B-A6A7-46AC243B6703}" type="datetimeFigureOut">
              <a:rPr lang="en-GB" smtClean="0"/>
              <a:t>21/01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2A4AA6-8C3D-4064-8D20-60AEA9B19B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908EB9F-1B3B-455A-9D40-5ED071455F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9B8440-9585-4C94-ABBA-FBD027A79E6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81327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4A1FD74-7207-49F1-9A18-159C06ECB02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5EEBCA9-CD58-4288-8E86-C6B9FFC2229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3872C89-ABC7-4CB1-8523-2B2AFF2EA2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E3305C-62ED-462B-A6A7-46AC243B6703}" type="datetimeFigureOut">
              <a:rPr lang="en-GB" smtClean="0"/>
              <a:t>21/01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57ADC7B-5E8F-4824-8A13-FB95F56FDF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49CE196-F718-428F-8DA8-F5162FC431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9B8440-9585-4C94-ABBA-FBD027A79E6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00313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1255A5-8117-457E-8D76-B1889F1BD5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FAB9EDA-9792-4A33-BD60-6DC78C75CC3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0B20B4-C4BD-4E92-8B85-8C6561DFC3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E3305C-62ED-462B-A6A7-46AC243B6703}" type="datetimeFigureOut">
              <a:rPr lang="en-GB" smtClean="0"/>
              <a:t>21/01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33A5F5C-7A97-4EC3-8E8A-A139FD80BC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8CACDFD-54ED-41AE-AA77-49029BFEE3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9B8440-9585-4C94-ABBA-FBD027A79E6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32841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A712B9-6FCB-4351-BC38-AD36D05D18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9379140-C9E3-4385-A910-46FF7725529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D1ADB96-D150-49E4-84D1-ADE63BCF2E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E3305C-62ED-462B-A6A7-46AC243B6703}" type="datetimeFigureOut">
              <a:rPr lang="en-GB" smtClean="0"/>
              <a:t>21/01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3F5902F-4786-4A62-80C9-C6B86B9ACE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8E87C5-3540-47CF-9C22-D4EEC91587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9B8440-9585-4C94-ABBA-FBD027A79E6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617509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D994C5-AF72-4AFA-82EB-C388573664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13C33F1-5CF2-4568-93F9-4D78E48CDAA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5453F88-EB88-4A68-80D3-C774A4672D2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70D2CFC-B693-4976-9559-E0F7870987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E3305C-62ED-462B-A6A7-46AC243B6703}" type="datetimeFigureOut">
              <a:rPr lang="en-GB" smtClean="0"/>
              <a:t>21/01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BB0966D-8F21-4A19-9F92-B593568F53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64D75BB-9108-485E-867E-22A73FDB0B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9B8440-9585-4C94-ABBA-FBD027A79E6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142606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850AF3-86FD-4D61-9278-362573400F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D14FFDB-6C62-4D34-A24E-69787FE8002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53B81AD-2C2B-4E7B-9C9D-95C9EF7FAD7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1DD4320-18C9-406B-AD62-8AACCDEB834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F9A0439-2CEB-40EB-9D48-298C2FFF494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1AAE0C1-3D85-4141-AFA7-CC098629C9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E3305C-62ED-462B-A6A7-46AC243B6703}" type="datetimeFigureOut">
              <a:rPr lang="en-GB" smtClean="0"/>
              <a:t>21/01/2021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3DC2DD8-D4B4-4621-937D-60F41512C8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ABFE7DF-99F1-4553-B05D-6A316599F3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9B8440-9585-4C94-ABBA-FBD027A79E6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2209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4DBE21-52FA-45AC-ABCA-6BF5D5F011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C31A35E-D85F-4F53-9E61-E37A8AEC78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E3305C-62ED-462B-A6A7-46AC243B6703}" type="datetimeFigureOut">
              <a:rPr lang="en-GB" smtClean="0"/>
              <a:t>21/01/2021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2D205DA-5497-495B-8DDF-84BFFDDF10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98BB159-102C-413C-AA63-1021557F73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9B8440-9585-4C94-ABBA-FBD027A79E6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024311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EF8BA79-ED0A-4F7E-807F-1F6BAA1BC9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E3305C-62ED-462B-A6A7-46AC243B6703}" type="datetimeFigureOut">
              <a:rPr lang="en-GB" smtClean="0"/>
              <a:t>21/01/2021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DCD8E3D-FDF1-4BB2-B09D-880E9D6BF7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E0B36BB-52CA-4C45-8568-574D541FC4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9B8440-9585-4C94-ABBA-FBD027A79E6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295235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BD0B5F-9D1C-4DDC-A593-E52E34138E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8286AB3-CA90-419F-BF7B-2663E420DAF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F69CEB7-4D6C-492A-8F3C-0B3FEE71E5B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4A71452-8C14-4EB3-B784-06C171C09D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E3305C-62ED-462B-A6A7-46AC243B6703}" type="datetimeFigureOut">
              <a:rPr lang="en-GB" smtClean="0"/>
              <a:t>21/01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CE0064D-F5E5-430A-AAE1-E60D89F587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DC7D584-FF90-4B34-9FF6-600BF16664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9B8440-9585-4C94-ABBA-FBD027A79E6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422544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DAB4BB-3930-4F08-A907-99E2BC6B4B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C68D73E-08B5-4F32-8B42-644A2A68569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9BA2367-A72D-40CB-A668-E88E3DA76F2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A89970D-4065-4928-A173-48AFC935D7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E3305C-62ED-462B-A6A7-46AC243B6703}" type="datetimeFigureOut">
              <a:rPr lang="en-GB" smtClean="0"/>
              <a:t>21/01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DCEC19D-B0F6-4917-9497-E9675DBE2C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CC56E01-EF44-4974-A9FA-FF451E97B5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9B8440-9585-4C94-ABBA-FBD027A79E6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683850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163C853-A65A-421A-81EE-4E2DAD0950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F8935AC-981B-4344-AE0F-3AF4C09EEC8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8FFA34F-2B1C-4B55-9C89-8741E573207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E3305C-62ED-462B-A6A7-46AC243B6703}" type="datetimeFigureOut">
              <a:rPr lang="en-GB" smtClean="0"/>
              <a:t>21/01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E46DF4C-DC04-4E16-95B0-F891D91EE0B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42CD4AB-6E8F-4581-AEE4-0DC529C9C50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9B8440-9585-4C94-ABBA-FBD027A79E6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328472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09414907-1EA5-4573-89E9-A54E0267083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35892" y="126499"/>
            <a:ext cx="7837950" cy="4410264"/>
          </a:xfrm>
          <a:prstGeom prst="rect">
            <a:avLst/>
          </a:prstGeom>
          <a:noFill/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CF75D7C3-1396-40B6-96CF-C6EE1197359E}"/>
              </a:ext>
            </a:extLst>
          </p:cNvPr>
          <p:cNvSpPr txBox="1"/>
          <p:nvPr/>
        </p:nvSpPr>
        <p:spPr>
          <a:xfrm>
            <a:off x="370433" y="4423177"/>
            <a:ext cx="11451133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. 1 | Titre- and time-dependent SARS-CoV-2 infection of hESC-derived cardiomyocytes.</a:t>
            </a:r>
            <a:r>
              <a:rPr lang="en-GB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Representative fluorescent images (n=2 independent experiments) of human embryonic stem cell-derived cardiomyocytes (hESC-CMs) infected with SARS-CoV-2 at several different viral titres ((0.001-0.1 multiplicity of infection (MOI)), or left untreated, and incubated for different time periods (24-72 h). Infected cells were immunolabelled after fixation with 2% formaldehyde and permeabilization with BD Perm/Wash buffer (BD Biosciences, 554723</a:t>
            </a:r>
            <a:r>
              <a:rPr lang="en-GB" sz="1800" dirty="0">
                <a:solidFill>
                  <a:srgbClr val="6F6C6C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  <a:r>
              <a:rPr lang="en-GB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using sheep anti-SARS-CoV-2 nucleocapsid antibody (DA114, MRC-PPU). Cells were visualised using a donkey anti-sheep secondary antibody conjugated to Alexa Fluor 488 (green) (Jackson </a:t>
            </a:r>
            <a:r>
              <a:rPr lang="en-GB" sz="18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mmunoResearch</a:t>
            </a:r>
            <a:r>
              <a:rPr lang="en-GB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#713-545-147).</a:t>
            </a:r>
            <a:endParaRPr lang="en-GB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167226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20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om Williams</dc:creator>
  <cp:lastModifiedBy>Tom Williams</cp:lastModifiedBy>
  <cp:revision>1</cp:revision>
  <dcterms:created xsi:type="dcterms:W3CDTF">2021-01-21T09:29:07Z</dcterms:created>
  <dcterms:modified xsi:type="dcterms:W3CDTF">2021-01-21T09:31:41Z</dcterms:modified>
</cp:coreProperties>
</file>